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6"/>
    <p:restoredTop sz="94684"/>
  </p:normalViewPr>
  <p:slideViewPr>
    <p:cSldViewPr snapToGrid="0" snapToObjects="1">
      <p:cViewPr varScale="1">
        <p:scale>
          <a:sx n="95" d="100"/>
          <a:sy n="95" d="100"/>
        </p:scale>
        <p:origin x="216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1011463-340C-6047-B159-E58A686546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8F55F1E-2CDD-BD45-B01D-6EE3E12098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3C07B01-2EC5-0F46-B50E-190D6AB57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2CD99E0-8329-644B-BD2A-9A4F07656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DC18BA9-6B8C-EA42-A255-ECE8F9D62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085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51F189-86DF-3345-97A2-27BD29B4A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EBF773E-3AF9-F344-9D14-DAAE0FEA6D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E32F885-685D-1A43-9AF2-6E179D04A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98994FD-5175-7C40-A216-460AB59C0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CEA0771-2AAE-8B41-BE17-E7B436FCD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5367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E8FC626-A1B8-B842-A631-60D6B714A2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CB849C3C-26F7-1E4D-BDAE-8EDB3BC569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24DB95-4F5F-3E4E-BFC0-73EA0E467F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C36DFF4-AA52-C145-891E-DDF303FAF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4F639A3-DFB6-CB4B-B414-B5D5B9DBB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5343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68AA15B-3E9C-1048-9850-54F5F11086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B2C525D-503A-F649-B046-5391E8CDD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5828AA0-CAA6-F942-BC25-5ECB348316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947A78B-E8B9-4949-87D4-581EDDC46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7FCA96B-2F06-AF45-BE3E-7A6E7EF82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9328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8278A2-2B37-A045-B425-A11CCF2315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15EBEAC-DC2E-E84A-9892-DDB44D4A62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62BFCE0-D26A-2043-9608-8E0DE9568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1788C6B-AF88-0C44-803D-58AEBE94B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DD10C80-4B0C-E74B-B057-25542DC64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6348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4559CC8-5C0F-E44A-8D34-B2CA8BF578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A83995E-14F3-864F-A428-E0CF33C7D0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4BFE48F1-BA12-5C41-8622-171FAE548F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92FCE23-AD8B-EB44-B2EB-497736E9C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4BF177E-BB95-3D47-AEFA-976B8BB93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D2309AA-BFBC-A942-9898-459DC0D08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0995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902D52-3D77-6B47-BF96-562416BE24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EC5BB07-BE96-224C-BC4F-87649D7E4A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5C62253-2034-984B-A0D4-1E7253EDE6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A52FD52-8706-1A41-A642-16EAB6A40D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BBBF4E6-5C9C-484D-8745-7266D47639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4AE1DFF4-BE99-3148-B69D-3F17BD0EC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236D839-820D-5F43-A3BC-5C37D20D9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F752CBE-A34E-DE43-9178-96182B4DA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7080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8061F36-AAE8-8F49-B605-7300A6F469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446772E-678B-7649-A478-DE93F3200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B1FA11B-312A-3945-A6E5-06FBBECD7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D4E80A41-B26D-1F40-9ACA-ACCE154EE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438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4E8C4AE-AC6C-2B42-8DA3-722C18644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919D3E30-DF76-3942-95B0-17B9BFB80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05E9F24-9BCC-9A48-8ADE-66C884875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5651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3474305-FB5C-BD46-A32E-F2A37AC269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2817CDA-5A49-604F-A152-02BC65FB6D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AFFFB97-9141-3749-AD6D-10BD6A64D1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BAFD2A1-8642-714E-8691-6EEDBEA8F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1268961-AB63-9E4D-9469-B89D07FB2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178A685-8038-DB46-85FA-B86F94CA5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8328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D821DFF-D7E1-A948-9117-9C60C3CDA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A211B72-027D-FF42-9D0D-A5B76A4919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CAFDF54-A875-0140-8889-72E3F0E44E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D4D36A9-037D-D64F-8B2E-8FEDCCD0C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D202E9F-BAF5-C542-8469-4203AF707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61E2A37-A9FB-2F4B-A21C-BF227885E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0507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D01071C-2F8B-0940-802D-21D40BDC0C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A66ACA2-4993-704D-AEAD-AF7E19AE9A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54479D3-C2E5-544C-8D25-A71F98860F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99B29-88E2-2748-A892-500399B770EE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CDC9ADA-BC03-7B43-9521-DCDAFD9F3C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9A897C4-E37D-E24B-9E99-3D40F7EE05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80A41-AA42-BF4F-A822-0035A6CD74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6182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61B80781-684F-9247-8B9C-69C8C59A14C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1041"/>
          <a:stretch/>
        </p:blipFill>
        <p:spPr>
          <a:xfrm>
            <a:off x="622794" y="180767"/>
            <a:ext cx="3208976" cy="243180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46A121FB-C898-064A-BA99-07E3AC8580BF}"/>
              </a:ext>
            </a:extLst>
          </p:cNvPr>
          <p:cNvSpPr/>
          <p:nvPr/>
        </p:nvSpPr>
        <p:spPr>
          <a:xfrm>
            <a:off x="622794" y="2789205"/>
            <a:ext cx="32089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/>
              <a:t>LOC_Os01g70380 Serine </a:t>
            </a:r>
            <a:r>
              <a:rPr lang="fr-FR" sz="1200" b="1" dirty="0" err="1"/>
              <a:t>palmitoyltransferase</a:t>
            </a:r>
            <a:endParaRPr lang="fr-FR" sz="1200" b="1" dirty="0"/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E4EAEBFC-3A8B-0D4F-A246-BC2889BBDBD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622" b="-1"/>
          <a:stretch/>
        </p:blipFill>
        <p:spPr>
          <a:xfrm>
            <a:off x="4209143" y="180767"/>
            <a:ext cx="3190623" cy="2431803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A927DE7D-1AB3-EC49-9472-929CDEFBA8DA}"/>
              </a:ext>
            </a:extLst>
          </p:cNvPr>
          <p:cNvSpPr/>
          <p:nvPr/>
        </p:nvSpPr>
        <p:spPr>
          <a:xfrm>
            <a:off x="4368800" y="2789205"/>
            <a:ext cx="26957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/>
              <a:t>LOC_Os08g44750 </a:t>
            </a:r>
            <a:r>
              <a:rPr lang="fr-FR" sz="1200" b="1" dirty="0" err="1"/>
              <a:t>Nodulin-like</a:t>
            </a:r>
            <a:r>
              <a:rPr lang="fr-FR" sz="1200" b="1" dirty="0"/>
              <a:t> </a:t>
            </a:r>
            <a:r>
              <a:rPr lang="fr-FR" sz="1200" b="1" dirty="0" err="1"/>
              <a:t>protein</a:t>
            </a:r>
            <a:endParaRPr lang="fr-FR" sz="1200" b="1" dirty="0"/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A490F3B0-C8FA-5645-9051-17C3E6D384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45828" y="180767"/>
            <a:ext cx="3251199" cy="2438399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242D837B-2C73-3347-802A-8579F6EC42B2}"/>
              </a:ext>
            </a:extLst>
          </p:cNvPr>
          <p:cNvSpPr/>
          <p:nvPr/>
        </p:nvSpPr>
        <p:spPr>
          <a:xfrm>
            <a:off x="7445828" y="2789204"/>
            <a:ext cx="393337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/>
              <a:t>LOC_Os10g39890 Pollen </a:t>
            </a:r>
            <a:r>
              <a:rPr lang="fr-FR" sz="1200" b="1" dirty="0" err="1"/>
              <a:t>Ole</a:t>
            </a:r>
            <a:r>
              <a:rPr lang="fr-FR" sz="1200" b="1" dirty="0"/>
              <a:t> 1 </a:t>
            </a:r>
            <a:r>
              <a:rPr lang="fr-FR" sz="1200" b="1" dirty="0" err="1"/>
              <a:t>allergen</a:t>
            </a:r>
            <a:r>
              <a:rPr lang="fr-FR" sz="1200" b="1" dirty="0"/>
              <a:t> 	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232498B5-2132-ED4F-9BCB-A09B3AC913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1715" y="3242839"/>
            <a:ext cx="3256814" cy="2442611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BA2ED6A8-BAA7-8649-95D0-4EB4365217E8}"/>
              </a:ext>
            </a:extLst>
          </p:cNvPr>
          <p:cNvSpPr/>
          <p:nvPr/>
        </p:nvSpPr>
        <p:spPr>
          <a:xfrm>
            <a:off x="622794" y="5862085"/>
            <a:ext cx="319709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b="1" dirty="0"/>
              <a:t>LOC_Os10g18820 Plant </a:t>
            </a:r>
            <a:r>
              <a:rPr lang="fr-FR" sz="1200" b="1" dirty="0" err="1"/>
              <a:t>disease</a:t>
            </a:r>
            <a:r>
              <a:rPr lang="fr-FR" sz="1200" b="1" dirty="0"/>
              <a:t> </a:t>
            </a:r>
            <a:r>
              <a:rPr lang="fr-FR" sz="1200" b="1" dirty="0" err="1"/>
              <a:t>response</a:t>
            </a:r>
            <a:r>
              <a:rPr lang="fr-FR" sz="1200" b="1" dirty="0"/>
              <a:t> </a:t>
            </a:r>
            <a:r>
              <a:rPr lang="fr-FR" sz="1200" b="1" dirty="0" err="1"/>
              <a:t>prot</a:t>
            </a:r>
            <a:r>
              <a:rPr lang="fr-FR" sz="1200" b="1" dirty="0"/>
              <a:t>.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B076303-95AC-F049-A190-067A573671E0}"/>
              </a:ext>
            </a:extLst>
          </p:cNvPr>
          <p:cNvSpPr/>
          <p:nvPr/>
        </p:nvSpPr>
        <p:spPr>
          <a:xfrm>
            <a:off x="622793" y="6374762"/>
            <a:ext cx="89605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>
                <a:latin typeface="Cambria" panose="02040503050406030204" pitchFamily="18" charset="0"/>
              </a:rPr>
              <a:t>Supplemental</a:t>
            </a:r>
            <a:r>
              <a:rPr lang="fr-FR" b="1" dirty="0">
                <a:latin typeface="Cambria" panose="02040503050406030204" pitchFamily="18" charset="0"/>
              </a:rPr>
              <a:t> </a:t>
            </a:r>
            <a:r>
              <a:rPr lang="fr-FR" b="1">
                <a:latin typeface="Cambria" panose="02040503050406030204" pitchFamily="18" charset="0"/>
              </a:rPr>
              <a:t>Figure S3</a:t>
            </a:r>
            <a:endParaRPr lang="fr-FR" b="1" dirty="0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789561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28</Words>
  <Application>Microsoft Macintosh PowerPoint</Application>
  <PresentationFormat>Grand écran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6</cp:revision>
  <cp:lastPrinted>2019-03-15T13:15:16Z</cp:lastPrinted>
  <dcterms:created xsi:type="dcterms:W3CDTF">2019-03-15T10:05:35Z</dcterms:created>
  <dcterms:modified xsi:type="dcterms:W3CDTF">2020-02-20T14:14:45Z</dcterms:modified>
</cp:coreProperties>
</file>